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94"/>
    <p:restoredTop sz="94604"/>
  </p:normalViewPr>
  <p:slideViewPr>
    <p:cSldViewPr snapToGrid="0" snapToObjects="1">
      <p:cViewPr varScale="1">
        <p:scale>
          <a:sx n="110" d="100"/>
          <a:sy n="110" d="100"/>
        </p:scale>
        <p:origin x="60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11A8C63-42E5-F546-BF10-545F7CCE192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B664F370-E993-3D41-AD66-E41DB7BFD3F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1D30F8D6-6E4C-D34F-9F4A-D51B356362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ACCA2E-F80E-4F4A-8799-49D3177D3CF7}" type="datetimeFigureOut">
              <a:rPr lang="de-DE" smtClean="0"/>
              <a:t>29.01.2021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8890D7AD-C59C-5743-BFF5-C29B7A2453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BC0E39C7-B27A-8842-B958-E2EC758CE7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4DF7C-4EF3-BE48-9D74-7A68EA0515D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012147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59B2703-8624-654B-86E7-6D5D80D53F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1986505B-2708-6447-A7D7-469020402F9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D8D6B6C9-7E9B-C647-B529-BD795E8AAE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ACCA2E-F80E-4F4A-8799-49D3177D3CF7}" type="datetimeFigureOut">
              <a:rPr lang="de-DE" smtClean="0"/>
              <a:t>29.01.2021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EE6ED91A-594A-F042-A15E-5792CDD944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3F460F99-3EE2-F84A-85C6-766FF84E47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4DF7C-4EF3-BE48-9D74-7A68EA0515D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064528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27303E37-AAC7-5548-A43C-F2F4C8903E9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ABEC5378-E703-E042-8A7A-8BE97929CE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03C319DC-953F-3847-A080-F3D2B1F6BF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ACCA2E-F80E-4F4A-8799-49D3177D3CF7}" type="datetimeFigureOut">
              <a:rPr lang="de-DE" smtClean="0"/>
              <a:t>29.01.2021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7255F04-9734-2143-BCC0-F15AE39121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11BDC68F-C9E2-3E48-BDDE-D0417ED25D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4DF7C-4EF3-BE48-9D74-7A68EA0515D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450974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8F1F57A-914F-B341-8063-913276AA71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C850AB94-7A6C-7241-A9B0-59EDE25AD80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5D324728-CA5B-9240-A23C-63E582C608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ACCA2E-F80E-4F4A-8799-49D3177D3CF7}" type="datetimeFigureOut">
              <a:rPr lang="de-DE" smtClean="0"/>
              <a:t>29.01.2021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5F49BFEC-DF51-1D46-BF5E-A55DF3E18E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453B2845-F28D-B046-8183-F795406E91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4DF7C-4EF3-BE48-9D74-7A68EA0515D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691375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A46EEB1-53E0-3F4B-BFD2-81079162F7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BE4DB1DE-9949-6D4F-8127-51D370E2CB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9EBCF16F-ACC8-0B43-8BB1-904EF8968E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ACCA2E-F80E-4F4A-8799-49D3177D3CF7}" type="datetimeFigureOut">
              <a:rPr lang="de-DE" smtClean="0"/>
              <a:t>29.01.2021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A64D039-97A5-CB48-BAA4-E15E825137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422FAC55-3D43-934C-93E4-1E20E5B7DA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4DF7C-4EF3-BE48-9D74-7A68EA0515D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88983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A978F67-82AE-EA45-92CD-A2D379F41B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5653FD90-F24F-E049-B347-A27E32EB421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AE925345-C8EF-D641-ADA2-01F9F1A5405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E2505078-480B-E444-9897-0BEBDE4827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ACCA2E-F80E-4F4A-8799-49D3177D3CF7}" type="datetimeFigureOut">
              <a:rPr lang="de-DE" smtClean="0"/>
              <a:t>29.01.2021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DD2606B0-5560-AB47-BCD2-39822EC1A1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691ACEC0-ED57-9E4C-BA29-B8876F5803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4DF7C-4EF3-BE48-9D74-7A68EA0515D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90262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B26C3F1-E305-6B4C-894F-6584E63EA0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04E87BB4-995E-C044-BB1A-C011D712CE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2C23B00C-047C-8549-9696-8A334F12EE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2ADD4398-3A1A-514A-BEC5-EDFEDE11DDD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7123D0BC-40BD-5F41-94E7-3B9ED0EC93B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B238007E-D7DE-D841-BEDE-A6108C1CF5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ACCA2E-F80E-4F4A-8799-49D3177D3CF7}" type="datetimeFigureOut">
              <a:rPr lang="de-DE" smtClean="0"/>
              <a:t>29.01.2021</a:t>
            </a:fld>
            <a:endParaRPr lang="de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129DDCD6-A088-C14A-A2FF-F4303FC3D0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BBA2FA9D-590D-5649-BD7A-D7CFBAAD2E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4DF7C-4EF3-BE48-9D74-7A68EA0515D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096147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E182044-1E85-3F44-9F5D-54A408773E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F57F3E58-35A6-F44F-A82C-348EDC14E7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ACCA2E-F80E-4F4A-8799-49D3177D3CF7}" type="datetimeFigureOut">
              <a:rPr lang="de-DE" smtClean="0"/>
              <a:t>29.01.2021</a:t>
            </a:fld>
            <a:endParaRPr lang="de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B12A1365-267E-B44A-9E1E-3EF910A9C9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99F6B080-BE42-C843-B5E0-E2E2DF8BA3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4DF7C-4EF3-BE48-9D74-7A68EA0515D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559550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3275864C-EAA9-3244-AACF-FF7A293A0D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ACCA2E-F80E-4F4A-8799-49D3177D3CF7}" type="datetimeFigureOut">
              <a:rPr lang="de-DE" smtClean="0"/>
              <a:t>29.01.2021</a:t>
            </a:fld>
            <a:endParaRPr lang="de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896EFAE9-AE44-2B4B-8525-74DF3FF205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C3A104F3-DF9F-EF48-951F-E8604A3F86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4DF7C-4EF3-BE48-9D74-7A68EA0515D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156917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44FF74D-4187-2848-BD83-2FCFA6CEA9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ABB3BF25-C7CA-9A49-8653-D1262DE50C4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AB976C20-2A9A-C641-A15D-4B47695C0E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51CC158D-3C44-4041-9053-41A81A0897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ACCA2E-F80E-4F4A-8799-49D3177D3CF7}" type="datetimeFigureOut">
              <a:rPr lang="de-DE" smtClean="0"/>
              <a:t>29.01.2021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5894DD59-747B-D848-AD07-68DBE372B7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3AC13BC1-AA78-764C-A6E0-3E807ECA3B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4DF7C-4EF3-BE48-9D74-7A68EA0515D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361443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6C1C156-8B42-5E43-A76E-EC417F4616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49046217-7DC2-9E4A-B8E4-9BB044E6FF0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821826A6-495A-8647-9191-086493EC835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E7ECAB6C-9B1D-7644-8595-DB3EFCC42A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ACCA2E-F80E-4F4A-8799-49D3177D3CF7}" type="datetimeFigureOut">
              <a:rPr lang="de-DE" smtClean="0"/>
              <a:t>29.01.2021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1B58A499-E1B8-3A41-96BC-E6E330A41C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9D21644A-8AD8-AC4E-BC8F-E005524B60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4DF7C-4EF3-BE48-9D74-7A68EA0515D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256737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1D6B6A6D-60F5-AE40-A139-71E4EB7682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835373C6-F685-4240-81F6-6843813D18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66D30955-9530-FC4C-B1FF-4F05AAB6ED4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ACCA2E-F80E-4F4A-8799-49D3177D3CF7}" type="datetimeFigureOut">
              <a:rPr lang="de-DE" smtClean="0"/>
              <a:t>29.01.2021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330942E6-DFFE-7E44-8193-1401D04E4CB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7B080AC5-3EEC-E347-A634-630026ACA8E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34DF7C-4EF3-BE48-9D74-7A68EA0515D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202362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8.png" descr="A close up of a map&#10;&#10;Description automatically generated">
            <a:extLst>
              <a:ext uri="{FF2B5EF4-FFF2-40B4-BE49-F238E27FC236}">
                <a16:creationId xmlns:a16="http://schemas.microsoft.com/office/drawing/2014/main" xmlns="" id="{807B8F37-DFF5-D146-AEEA-75D64172F230}"/>
              </a:ext>
            </a:extLst>
          </p:cNvPr>
          <p:cNvPicPr/>
          <p:nvPr/>
        </p:nvPicPr>
        <p:blipFill>
          <a:blip r:embed="rId2"/>
          <a:srcRect/>
          <a:stretch>
            <a:fillRect/>
          </a:stretch>
        </p:blipFill>
        <p:spPr>
          <a:xfrm>
            <a:off x="2796280" y="446086"/>
            <a:ext cx="7028659" cy="5111752"/>
          </a:xfrm>
          <a:prstGeom prst="rect">
            <a:avLst/>
          </a:prstGeom>
          <a:ln/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xmlns="" id="{398517BE-F089-0142-8BDD-F06D2F2D3961}"/>
              </a:ext>
            </a:extLst>
          </p:cNvPr>
          <p:cNvSpPr/>
          <p:nvPr/>
        </p:nvSpPr>
        <p:spPr>
          <a:xfrm>
            <a:off x="3005138" y="5704178"/>
            <a:ext cx="6610945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b="1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upplementary </a:t>
            </a:r>
            <a:r>
              <a:rPr lang="en-US" b="1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figure </a:t>
            </a:r>
            <a:r>
              <a:rPr lang="en-US" b="1" smtClean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4.</a:t>
            </a:r>
            <a:r>
              <a:rPr lang="en-US" smtClean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n-US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Kaplan-Meier curves showing the survival of included patients according to tumor entity. </a:t>
            </a:r>
            <a:endParaRPr lang="de-DE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789034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e Mihaljevic</dc:creator>
  <cp:lastModifiedBy>Srikanth N.</cp:lastModifiedBy>
  <cp:revision>2</cp:revision>
  <dcterms:created xsi:type="dcterms:W3CDTF">2020-10-03T07:18:05Z</dcterms:created>
  <dcterms:modified xsi:type="dcterms:W3CDTF">2021-01-29T09:57:03Z</dcterms:modified>
</cp:coreProperties>
</file>